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i1QC+is8drPXgcqPJ0RE2tq9Sy7g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84F7F73-2CE7-8695-C1A5-8F0F48F619FD}" name="Mary  Njoroge" initials="MN" userId="S::lshmn48@lshtm.ac.uk::f8e81db1-9b6a-4e67-8d90-3ab2f80e2780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D51BE"/>
    <a:srgbClr val="E03ED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CEC8519-1AD5-4052-AF8E-F7B682BFBF80}" v="118" dt="2025-02-11T16:58:29.0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582" y="96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13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5" Type="http://schemas.microsoft.com/office/2018/10/relationships/authors" Target="authors.xml"/><Relationship Id="rId10" Type="http://schemas.openxmlformats.org/officeDocument/2006/relationships/viewProps" Target="viewProps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rlotte  Rutter" userId="160ff53a-fbf8-44e9-bd7d-8596248049be" providerId="ADAL" clId="{5CEC8519-1AD5-4052-AF8E-F7B682BFBF80}"/>
    <pc:docChg chg="undo custSel modSld">
      <pc:chgData name="Charlotte  Rutter" userId="160ff53a-fbf8-44e9-bd7d-8596248049be" providerId="ADAL" clId="{5CEC8519-1AD5-4052-AF8E-F7B682BFBF80}" dt="2025-02-11T16:59:40.625" v="1108" actId="14100"/>
      <pc:docMkLst>
        <pc:docMk/>
      </pc:docMkLst>
      <pc:sldChg chg="addSp delSp modSp mod">
        <pc:chgData name="Charlotte  Rutter" userId="160ff53a-fbf8-44e9-bd7d-8596248049be" providerId="ADAL" clId="{5CEC8519-1AD5-4052-AF8E-F7B682BFBF80}" dt="2025-02-11T16:59:40.625" v="1108" actId="14100"/>
        <pc:sldMkLst>
          <pc:docMk/>
          <pc:sldMk cId="0" sldId="257"/>
        </pc:sldMkLst>
        <pc:spChg chg="mod">
          <ac:chgData name="Charlotte  Rutter" userId="160ff53a-fbf8-44e9-bd7d-8596248049be" providerId="ADAL" clId="{5CEC8519-1AD5-4052-AF8E-F7B682BFBF80}" dt="2025-02-11T16:05:26.293" v="210" actId="1076"/>
          <ac:spMkLst>
            <pc:docMk/>
            <pc:sldMk cId="0" sldId="257"/>
            <ac:spMk id="2" creationId="{023464F7-8D7C-E429-5495-D8812C6A72F6}"/>
          </ac:spMkLst>
        </pc:spChg>
        <pc:spChg chg="mod">
          <ac:chgData name="Charlotte  Rutter" userId="160ff53a-fbf8-44e9-bd7d-8596248049be" providerId="ADAL" clId="{5CEC8519-1AD5-4052-AF8E-F7B682BFBF80}" dt="2025-02-11T16:05:46.621" v="212" actId="1076"/>
          <ac:spMkLst>
            <pc:docMk/>
            <pc:sldMk cId="0" sldId="257"/>
            <ac:spMk id="3" creationId="{5A22B126-E4A0-C34F-F7AE-03BB57DCA051}"/>
          </ac:spMkLst>
        </pc:spChg>
        <pc:spChg chg="mod">
          <ac:chgData name="Charlotte  Rutter" userId="160ff53a-fbf8-44e9-bd7d-8596248049be" providerId="ADAL" clId="{5CEC8519-1AD5-4052-AF8E-F7B682BFBF80}" dt="2025-02-11T16:05:51.620" v="213" actId="1076"/>
          <ac:spMkLst>
            <pc:docMk/>
            <pc:sldMk cId="0" sldId="257"/>
            <ac:spMk id="4" creationId="{79BDF7C3-2189-D9F6-4993-5CC83D23270E}"/>
          </ac:spMkLst>
        </pc:spChg>
        <pc:spChg chg="mod">
          <ac:chgData name="Charlotte  Rutter" userId="160ff53a-fbf8-44e9-bd7d-8596248049be" providerId="ADAL" clId="{5CEC8519-1AD5-4052-AF8E-F7B682BFBF80}" dt="2025-02-11T16:05:32.612" v="211" actId="1076"/>
          <ac:spMkLst>
            <pc:docMk/>
            <pc:sldMk cId="0" sldId="257"/>
            <ac:spMk id="5" creationId="{B6D58143-7E80-6CA1-3233-A2BBAD83599E}"/>
          </ac:spMkLst>
        </pc:spChg>
        <pc:spChg chg="mod">
          <ac:chgData name="Charlotte  Rutter" userId="160ff53a-fbf8-44e9-bd7d-8596248049be" providerId="ADAL" clId="{5CEC8519-1AD5-4052-AF8E-F7B682BFBF80}" dt="2025-02-11T16:06:06.308" v="216" actId="1076"/>
          <ac:spMkLst>
            <pc:docMk/>
            <pc:sldMk cId="0" sldId="257"/>
            <ac:spMk id="23" creationId="{40B18A10-B084-E30C-2972-7E65BE4FA923}"/>
          </ac:spMkLst>
        </pc:spChg>
        <pc:spChg chg="mod">
          <ac:chgData name="Charlotte  Rutter" userId="160ff53a-fbf8-44e9-bd7d-8596248049be" providerId="ADAL" clId="{5CEC8519-1AD5-4052-AF8E-F7B682BFBF80}" dt="2025-02-11T16:06:28.636" v="220" actId="1076"/>
          <ac:spMkLst>
            <pc:docMk/>
            <pc:sldMk cId="0" sldId="257"/>
            <ac:spMk id="25" creationId="{5F5680BE-12A6-B15A-7468-41B34A7C60CE}"/>
          </ac:spMkLst>
        </pc:spChg>
        <pc:spChg chg="mod">
          <ac:chgData name="Charlotte  Rutter" userId="160ff53a-fbf8-44e9-bd7d-8596248049be" providerId="ADAL" clId="{5CEC8519-1AD5-4052-AF8E-F7B682BFBF80}" dt="2025-02-11T16:06:23.644" v="219" actId="1076"/>
          <ac:spMkLst>
            <pc:docMk/>
            <pc:sldMk cId="0" sldId="257"/>
            <ac:spMk id="26" creationId="{8EAF57CA-6F7D-A94D-A440-89905AFADBEB}"/>
          </ac:spMkLst>
        </pc:spChg>
        <pc:spChg chg="mod">
          <ac:chgData name="Charlotte  Rutter" userId="160ff53a-fbf8-44e9-bd7d-8596248049be" providerId="ADAL" clId="{5CEC8519-1AD5-4052-AF8E-F7B682BFBF80}" dt="2025-02-11T16:06:01.636" v="215" actId="1076"/>
          <ac:spMkLst>
            <pc:docMk/>
            <pc:sldMk cId="0" sldId="257"/>
            <ac:spMk id="27" creationId="{9E4ACE2D-0999-0617-18F1-055013AE1ED4}"/>
          </ac:spMkLst>
        </pc:spChg>
        <pc:spChg chg="mod">
          <ac:chgData name="Charlotte  Rutter" userId="160ff53a-fbf8-44e9-bd7d-8596248049be" providerId="ADAL" clId="{5CEC8519-1AD5-4052-AF8E-F7B682BFBF80}" dt="2025-02-11T16:35:26.756" v="810" actId="1076"/>
          <ac:spMkLst>
            <pc:docMk/>
            <pc:sldMk cId="0" sldId="257"/>
            <ac:spMk id="28" creationId="{2AD2C3AB-1F38-CE05-C260-4AE5801C3129}"/>
          </ac:spMkLst>
        </pc:spChg>
        <pc:spChg chg="add mod">
          <ac:chgData name="Charlotte  Rutter" userId="160ff53a-fbf8-44e9-bd7d-8596248049be" providerId="ADAL" clId="{5CEC8519-1AD5-4052-AF8E-F7B682BFBF80}" dt="2025-02-11T16:57:40.525" v="1093" actId="14100"/>
          <ac:spMkLst>
            <pc:docMk/>
            <pc:sldMk cId="0" sldId="257"/>
            <ac:spMk id="45" creationId="{F4D122D0-B6D0-A85C-45B3-42CBE7C6AD2E}"/>
          </ac:spMkLst>
        </pc:spChg>
        <pc:spChg chg="add mod">
          <ac:chgData name="Charlotte  Rutter" userId="160ff53a-fbf8-44e9-bd7d-8596248049be" providerId="ADAL" clId="{5CEC8519-1AD5-4052-AF8E-F7B682BFBF80}" dt="2025-02-11T16:58:04.311" v="1100" actId="14100"/>
          <ac:spMkLst>
            <pc:docMk/>
            <pc:sldMk cId="0" sldId="257"/>
            <ac:spMk id="46" creationId="{84AC45AC-A5F5-D4B8-B680-31964A46C6AA}"/>
          </ac:spMkLst>
        </pc:spChg>
        <pc:spChg chg="add del">
          <ac:chgData name="Charlotte  Rutter" userId="160ff53a-fbf8-44e9-bd7d-8596248049be" providerId="ADAL" clId="{5CEC8519-1AD5-4052-AF8E-F7B682BFBF80}" dt="2025-02-11T16:11:56.460" v="424" actId="478"/>
          <ac:spMkLst>
            <pc:docMk/>
            <pc:sldMk cId="0" sldId="257"/>
            <ac:spMk id="47" creationId="{C4306D35-A0C2-8B9E-1716-EED66999856D}"/>
          </ac:spMkLst>
        </pc:spChg>
        <pc:spChg chg="add del mod">
          <ac:chgData name="Charlotte  Rutter" userId="160ff53a-fbf8-44e9-bd7d-8596248049be" providerId="ADAL" clId="{5CEC8519-1AD5-4052-AF8E-F7B682BFBF80}" dt="2025-02-11T16:18:23.848" v="550" actId="478"/>
          <ac:spMkLst>
            <pc:docMk/>
            <pc:sldMk cId="0" sldId="257"/>
            <ac:spMk id="48" creationId="{B71DB15D-5B96-CFEB-3652-9D9F692BD70D}"/>
          </ac:spMkLst>
        </pc:spChg>
        <pc:spChg chg="add mod">
          <ac:chgData name="Charlotte  Rutter" userId="160ff53a-fbf8-44e9-bd7d-8596248049be" providerId="ADAL" clId="{5CEC8519-1AD5-4052-AF8E-F7B682BFBF80}" dt="2025-02-11T16:57:53.294" v="1096" actId="14100"/>
          <ac:spMkLst>
            <pc:docMk/>
            <pc:sldMk cId="0" sldId="257"/>
            <ac:spMk id="49" creationId="{A01C925F-0159-1BD7-9A21-7F5FFA4DFA83}"/>
          </ac:spMkLst>
        </pc:spChg>
        <pc:spChg chg="mod">
          <ac:chgData name="Charlotte  Rutter" userId="160ff53a-fbf8-44e9-bd7d-8596248049be" providerId="ADAL" clId="{5CEC8519-1AD5-4052-AF8E-F7B682BFBF80}" dt="2025-02-11T16:53:12.401" v="1074" actId="20577"/>
          <ac:spMkLst>
            <pc:docMk/>
            <pc:sldMk cId="0" sldId="257"/>
            <ac:spMk id="50" creationId="{00000DB0-AFCF-702A-22DE-D97E63B286F9}"/>
          </ac:spMkLst>
        </pc:spChg>
        <pc:spChg chg="mod">
          <ac:chgData name="Charlotte  Rutter" userId="160ff53a-fbf8-44e9-bd7d-8596248049be" providerId="ADAL" clId="{5CEC8519-1AD5-4052-AF8E-F7B682BFBF80}" dt="2025-02-11T16:03:42.708" v="176" actId="1076"/>
          <ac:spMkLst>
            <pc:docMk/>
            <pc:sldMk cId="0" sldId="257"/>
            <ac:spMk id="51" creationId="{769E383B-F57C-D905-C773-2CF1DA8DCAE5}"/>
          </ac:spMkLst>
        </pc:spChg>
        <pc:spChg chg="mod">
          <ac:chgData name="Charlotte  Rutter" userId="160ff53a-fbf8-44e9-bd7d-8596248049be" providerId="ADAL" clId="{5CEC8519-1AD5-4052-AF8E-F7B682BFBF80}" dt="2025-02-11T16:03:50.710" v="177" actId="1076"/>
          <ac:spMkLst>
            <pc:docMk/>
            <pc:sldMk cId="0" sldId="257"/>
            <ac:spMk id="52" creationId="{27355349-79C3-F5CD-B6D8-87D690D96889}"/>
          </ac:spMkLst>
        </pc:spChg>
        <pc:spChg chg="mod">
          <ac:chgData name="Charlotte  Rutter" userId="160ff53a-fbf8-44e9-bd7d-8596248049be" providerId="ADAL" clId="{5CEC8519-1AD5-4052-AF8E-F7B682BFBF80}" dt="2025-02-11T16:03:55.245" v="178" actId="1076"/>
          <ac:spMkLst>
            <pc:docMk/>
            <pc:sldMk cId="0" sldId="257"/>
            <ac:spMk id="53" creationId="{5B53D39B-7720-B739-A75D-18101E4C81E2}"/>
          </ac:spMkLst>
        </pc:spChg>
        <pc:spChg chg="add">
          <ac:chgData name="Charlotte  Rutter" userId="160ff53a-fbf8-44e9-bd7d-8596248049be" providerId="ADAL" clId="{5CEC8519-1AD5-4052-AF8E-F7B682BFBF80}" dt="2025-02-11T16:17:52.555" v="545"/>
          <ac:spMkLst>
            <pc:docMk/>
            <pc:sldMk cId="0" sldId="257"/>
            <ac:spMk id="54" creationId="{15B5C300-8B5A-3B99-BD87-0BAF5B166D00}"/>
          </ac:spMkLst>
        </pc:spChg>
        <pc:spChg chg="add mod">
          <ac:chgData name="Charlotte  Rutter" userId="160ff53a-fbf8-44e9-bd7d-8596248049be" providerId="ADAL" clId="{5CEC8519-1AD5-4052-AF8E-F7B682BFBF80}" dt="2025-02-11T16:32:03.750" v="724" actId="122"/>
          <ac:spMkLst>
            <pc:docMk/>
            <pc:sldMk cId="0" sldId="257"/>
            <ac:spMk id="57" creationId="{F664DA28-921B-2E66-316C-C510F08DE6EB}"/>
          </ac:spMkLst>
        </pc:spChg>
        <pc:spChg chg="add mod ord">
          <ac:chgData name="Charlotte  Rutter" userId="160ff53a-fbf8-44e9-bd7d-8596248049be" providerId="ADAL" clId="{5CEC8519-1AD5-4052-AF8E-F7B682BFBF80}" dt="2025-02-11T16:36:31.997" v="818" actId="167"/>
          <ac:spMkLst>
            <pc:docMk/>
            <pc:sldMk cId="0" sldId="257"/>
            <ac:spMk id="58" creationId="{5A74F847-B264-DDCC-1F23-E307AB29FF1D}"/>
          </ac:spMkLst>
        </pc:spChg>
        <pc:spChg chg="add mod ord">
          <ac:chgData name="Charlotte  Rutter" userId="160ff53a-fbf8-44e9-bd7d-8596248049be" providerId="ADAL" clId="{5CEC8519-1AD5-4052-AF8E-F7B682BFBF80}" dt="2025-02-11T16:58:54.841" v="1107" actId="14100"/>
          <ac:spMkLst>
            <pc:docMk/>
            <pc:sldMk cId="0" sldId="257"/>
            <ac:spMk id="60" creationId="{E7A9505E-A7BF-6170-0B83-35AB5AEF4D81}"/>
          </ac:spMkLst>
        </pc:spChg>
        <pc:spChg chg="mod">
          <ac:chgData name="Charlotte  Rutter" userId="160ff53a-fbf8-44e9-bd7d-8596248049be" providerId="ADAL" clId="{5CEC8519-1AD5-4052-AF8E-F7B682BFBF80}" dt="2025-02-11T16:53:09.411" v="1073" actId="20577"/>
          <ac:spMkLst>
            <pc:docMk/>
            <pc:sldMk cId="0" sldId="257"/>
            <ac:spMk id="87" creationId="{2B5AEF3B-CF6D-F5F7-397E-52EE4D63242B}"/>
          </ac:spMkLst>
        </pc:spChg>
        <pc:spChg chg="mod">
          <ac:chgData name="Charlotte  Rutter" userId="160ff53a-fbf8-44e9-bd7d-8596248049be" providerId="ADAL" clId="{5CEC8519-1AD5-4052-AF8E-F7B682BFBF80}" dt="2025-02-11T16:04:13.645" v="180" actId="1076"/>
          <ac:spMkLst>
            <pc:docMk/>
            <pc:sldMk cId="0" sldId="257"/>
            <ac:spMk id="88" creationId="{0FC4B71F-4F0E-32B6-05F1-440FC49FD592}"/>
          </ac:spMkLst>
        </pc:spChg>
        <pc:spChg chg="del">
          <ac:chgData name="Charlotte  Rutter" userId="160ff53a-fbf8-44e9-bd7d-8596248049be" providerId="ADAL" clId="{5CEC8519-1AD5-4052-AF8E-F7B682BFBF80}" dt="2025-02-11T16:38:31.747" v="824" actId="478"/>
          <ac:spMkLst>
            <pc:docMk/>
            <pc:sldMk cId="0" sldId="257"/>
            <ac:spMk id="97" creationId="{00000000-0000-0000-0000-000000000000}"/>
          </ac:spMkLst>
        </pc:spChg>
        <pc:spChg chg="mod">
          <ac:chgData name="Charlotte  Rutter" userId="160ff53a-fbf8-44e9-bd7d-8596248049be" providerId="ADAL" clId="{5CEC8519-1AD5-4052-AF8E-F7B682BFBF80}" dt="2025-02-11T16:18:10.194" v="547" actId="14100"/>
          <ac:spMkLst>
            <pc:docMk/>
            <pc:sldMk cId="0" sldId="257"/>
            <ac:spMk id="101" creationId="{00000000-0000-0000-0000-000000000000}"/>
          </ac:spMkLst>
        </pc:spChg>
        <pc:spChg chg="mod">
          <ac:chgData name="Charlotte  Rutter" userId="160ff53a-fbf8-44e9-bd7d-8596248049be" providerId="ADAL" clId="{5CEC8519-1AD5-4052-AF8E-F7B682BFBF80}" dt="2025-02-11T16:59:40.625" v="1108" actId="14100"/>
          <ac:spMkLst>
            <pc:docMk/>
            <pc:sldMk cId="0" sldId="257"/>
            <ac:spMk id="110" creationId="{00000000-0000-0000-0000-000000000000}"/>
          </ac:spMkLst>
        </pc:spChg>
        <pc:spChg chg="mod">
          <ac:chgData name="Charlotte  Rutter" userId="160ff53a-fbf8-44e9-bd7d-8596248049be" providerId="ADAL" clId="{5CEC8519-1AD5-4052-AF8E-F7B682BFBF80}" dt="2025-02-11T16:34:49.336" v="789" actId="14100"/>
          <ac:spMkLst>
            <pc:docMk/>
            <pc:sldMk cId="0" sldId="257"/>
            <ac:spMk id="111" creationId="{00000000-0000-0000-0000-000000000000}"/>
          </ac:spMkLst>
        </pc:spChg>
        <pc:spChg chg="mod">
          <ac:chgData name="Charlotte  Rutter" userId="160ff53a-fbf8-44e9-bd7d-8596248049be" providerId="ADAL" clId="{5CEC8519-1AD5-4052-AF8E-F7B682BFBF80}" dt="2025-02-11T16:35:10.412" v="808" actId="14100"/>
          <ac:spMkLst>
            <pc:docMk/>
            <pc:sldMk cId="0" sldId="257"/>
            <ac:spMk id="112" creationId="{00000000-0000-0000-0000-000000000000}"/>
          </ac:spMkLst>
        </pc:spChg>
        <pc:spChg chg="del mod">
          <ac:chgData name="Charlotte  Rutter" userId="160ff53a-fbf8-44e9-bd7d-8596248049be" providerId="ADAL" clId="{5CEC8519-1AD5-4052-AF8E-F7B682BFBF80}" dt="2025-02-11T16:29:52.661" v="696" actId="478"/>
          <ac:spMkLst>
            <pc:docMk/>
            <pc:sldMk cId="0" sldId="257"/>
            <ac:spMk id="113" creationId="{00000000-0000-0000-0000-000000000000}"/>
          </ac:spMkLst>
        </pc:spChg>
        <pc:spChg chg="del">
          <ac:chgData name="Charlotte  Rutter" userId="160ff53a-fbf8-44e9-bd7d-8596248049be" providerId="ADAL" clId="{5CEC8519-1AD5-4052-AF8E-F7B682BFBF80}" dt="2025-02-11T15:26:55.324" v="15" actId="478"/>
          <ac:spMkLst>
            <pc:docMk/>
            <pc:sldMk cId="0" sldId="257"/>
            <ac:spMk id="118" creationId="{3C5844B7-4859-E100-A08D-2F5C5D0D2CBA}"/>
          </ac:spMkLst>
        </pc:spChg>
        <pc:spChg chg="mod">
          <ac:chgData name="Charlotte  Rutter" userId="160ff53a-fbf8-44e9-bd7d-8596248049be" providerId="ADAL" clId="{5CEC8519-1AD5-4052-AF8E-F7B682BFBF80}" dt="2025-02-11T16:04:22.317" v="181" actId="1076"/>
          <ac:spMkLst>
            <pc:docMk/>
            <pc:sldMk cId="0" sldId="257"/>
            <ac:spMk id="125" creationId="{034234FF-50D6-ACB5-B980-20392A9D6808}"/>
          </ac:spMkLst>
        </pc:spChg>
        <pc:spChg chg="mod">
          <ac:chgData name="Charlotte  Rutter" userId="160ff53a-fbf8-44e9-bd7d-8596248049be" providerId="ADAL" clId="{5CEC8519-1AD5-4052-AF8E-F7B682BFBF80}" dt="2025-02-11T16:04:32.141" v="182" actId="1076"/>
          <ac:spMkLst>
            <pc:docMk/>
            <pc:sldMk cId="0" sldId="257"/>
            <ac:spMk id="126" creationId="{3CD3797A-A615-58AA-C488-9FE71DAF53E4}"/>
          </ac:spMkLst>
        </pc:spChg>
        <pc:spChg chg="mod">
          <ac:chgData name="Charlotte  Rutter" userId="160ff53a-fbf8-44e9-bd7d-8596248049be" providerId="ADAL" clId="{5CEC8519-1AD5-4052-AF8E-F7B682BFBF80}" dt="2025-02-11T16:47:23.387" v="860" actId="1076"/>
          <ac:spMkLst>
            <pc:docMk/>
            <pc:sldMk cId="0" sldId="257"/>
            <ac:spMk id="169" creationId="{36EFAACE-B552-C222-2056-F00AE0187F26}"/>
          </ac:spMkLst>
        </pc:spChg>
        <pc:spChg chg="mod">
          <ac:chgData name="Charlotte  Rutter" userId="160ff53a-fbf8-44e9-bd7d-8596248049be" providerId="ADAL" clId="{5CEC8519-1AD5-4052-AF8E-F7B682BFBF80}" dt="2025-02-11T16:52:46.584" v="1071" actId="1076"/>
          <ac:spMkLst>
            <pc:docMk/>
            <pc:sldMk cId="0" sldId="257"/>
            <ac:spMk id="179" creationId="{6F65C90A-2058-D343-40E4-B6471100B6C0}"/>
          </ac:spMkLst>
        </pc:spChg>
        <pc:spChg chg="mod">
          <ac:chgData name="Charlotte  Rutter" userId="160ff53a-fbf8-44e9-bd7d-8596248049be" providerId="ADAL" clId="{5CEC8519-1AD5-4052-AF8E-F7B682BFBF80}" dt="2025-02-11T16:10:38.843" v="414" actId="20577"/>
          <ac:spMkLst>
            <pc:docMk/>
            <pc:sldMk cId="0" sldId="257"/>
            <ac:spMk id="186" creationId="{188F3B61-BB25-D9D9-758D-3994AD7E8467}"/>
          </ac:spMkLst>
        </pc:spChg>
        <pc:spChg chg="mod">
          <ac:chgData name="Charlotte  Rutter" userId="160ff53a-fbf8-44e9-bd7d-8596248049be" providerId="ADAL" clId="{5CEC8519-1AD5-4052-AF8E-F7B682BFBF80}" dt="2025-02-11T16:52:18.375" v="1070" actId="1076"/>
          <ac:spMkLst>
            <pc:docMk/>
            <pc:sldMk cId="0" sldId="257"/>
            <ac:spMk id="227" creationId="{80B8778B-6145-F0E2-8ACD-CC55494A89AD}"/>
          </ac:spMkLst>
        </pc:spChg>
        <pc:spChg chg="mod">
          <ac:chgData name="Charlotte  Rutter" userId="160ff53a-fbf8-44e9-bd7d-8596248049be" providerId="ADAL" clId="{5CEC8519-1AD5-4052-AF8E-F7B682BFBF80}" dt="2025-02-11T16:53:08.097" v="1072" actId="20577"/>
          <ac:spMkLst>
            <pc:docMk/>
            <pc:sldMk cId="0" sldId="257"/>
            <ac:spMk id="228" creationId="{15DFBD21-6DA1-58D9-D1B9-7AA68EB2C8EB}"/>
          </ac:spMkLst>
        </pc:spChg>
        <pc:picChg chg="del mod">
          <ac:chgData name="Charlotte  Rutter" userId="160ff53a-fbf8-44e9-bd7d-8596248049be" providerId="ADAL" clId="{5CEC8519-1AD5-4052-AF8E-F7B682BFBF80}" dt="2025-02-11T16:41:48.754" v="834" actId="478"/>
          <ac:picMkLst>
            <pc:docMk/>
            <pc:sldMk cId="0" sldId="257"/>
            <ac:picMk id="22" creationId="{00D24BC3-C8EC-C747-1357-10D0C5599428}"/>
          </ac:picMkLst>
        </pc:picChg>
        <pc:picChg chg="add del mod">
          <ac:chgData name="Charlotte  Rutter" userId="160ff53a-fbf8-44e9-bd7d-8596248049be" providerId="ADAL" clId="{5CEC8519-1AD5-4052-AF8E-F7B682BFBF80}" dt="2025-02-11T16:44:17.361" v="836" actId="478"/>
          <ac:picMkLst>
            <pc:docMk/>
            <pc:sldMk cId="0" sldId="257"/>
            <ac:picMk id="62" creationId="{33BB0E7E-D10A-D9CE-0431-360890394B26}"/>
          </ac:picMkLst>
        </pc:picChg>
        <pc:picChg chg="add mod">
          <ac:chgData name="Charlotte  Rutter" userId="160ff53a-fbf8-44e9-bd7d-8596248049be" providerId="ADAL" clId="{5CEC8519-1AD5-4052-AF8E-F7B682BFBF80}" dt="2025-02-11T16:44:39.539" v="841" actId="931"/>
          <ac:picMkLst>
            <pc:docMk/>
            <pc:sldMk cId="0" sldId="257"/>
            <ac:picMk id="65" creationId="{74B0F1F9-2C2F-811F-2057-CBB5A3BD8D95}"/>
          </ac:picMkLst>
        </pc:picChg>
        <pc:picChg chg="add mod">
          <ac:chgData name="Charlotte  Rutter" userId="160ff53a-fbf8-44e9-bd7d-8596248049be" providerId="ADAL" clId="{5CEC8519-1AD5-4052-AF8E-F7B682BFBF80}" dt="2025-02-11T16:45:28.130" v="851" actId="1076"/>
          <ac:picMkLst>
            <pc:docMk/>
            <pc:sldMk cId="0" sldId="257"/>
            <ac:picMk id="67" creationId="{7E418795-BD73-8FC7-AD35-EFA1AADCD473}"/>
          </ac:picMkLst>
        </pc:picChg>
        <pc:picChg chg="add del mod">
          <ac:chgData name="Charlotte  Rutter" userId="160ff53a-fbf8-44e9-bd7d-8596248049be" providerId="ADAL" clId="{5CEC8519-1AD5-4052-AF8E-F7B682BFBF80}" dt="2025-02-11T16:58:20.047" v="1103" actId="1076"/>
          <ac:picMkLst>
            <pc:docMk/>
            <pc:sldMk cId="0" sldId="257"/>
            <ac:picMk id="1026" creationId="{03C597C0-67C0-F70B-1D19-145181D5C8F9}"/>
          </ac:picMkLst>
        </pc:picChg>
        <pc:picChg chg="add del mod">
          <ac:chgData name="Charlotte  Rutter" userId="160ff53a-fbf8-44e9-bd7d-8596248049be" providerId="ADAL" clId="{5CEC8519-1AD5-4052-AF8E-F7B682BFBF80}" dt="2025-02-11T16:23:47.160" v="623" actId="478"/>
          <ac:picMkLst>
            <pc:docMk/>
            <pc:sldMk cId="0" sldId="257"/>
            <ac:picMk id="1030" creationId="{081F4EF2-2772-B266-A851-5095E51D729A}"/>
          </ac:picMkLst>
        </pc:picChg>
        <pc:picChg chg="add mod">
          <ac:chgData name="Charlotte  Rutter" userId="160ff53a-fbf8-44e9-bd7d-8596248049be" providerId="ADAL" clId="{5CEC8519-1AD5-4052-AF8E-F7B682BFBF80}" dt="2025-02-11T16:19:45.562" v="574" actId="14100"/>
          <ac:picMkLst>
            <pc:docMk/>
            <pc:sldMk cId="0" sldId="257"/>
            <ac:picMk id="1032" creationId="{E2C6AAD5-17B0-59B3-C3FA-4535F748D331}"/>
          </ac:picMkLst>
        </pc:picChg>
        <pc:picChg chg="add mod">
          <ac:chgData name="Charlotte  Rutter" userId="160ff53a-fbf8-44e9-bd7d-8596248049be" providerId="ADAL" clId="{5CEC8519-1AD5-4052-AF8E-F7B682BFBF80}" dt="2025-02-11T16:58:15.095" v="1101" actId="1076"/>
          <ac:picMkLst>
            <pc:docMk/>
            <pc:sldMk cId="0" sldId="257"/>
            <ac:picMk id="1034" creationId="{BAC71EAA-5613-6A1E-1E6E-AC83ECEE7AF2}"/>
          </ac:picMkLst>
        </pc:picChg>
        <pc:picChg chg="add mod">
          <ac:chgData name="Charlotte  Rutter" userId="160ff53a-fbf8-44e9-bd7d-8596248049be" providerId="ADAL" clId="{5CEC8519-1AD5-4052-AF8E-F7B682BFBF80}" dt="2025-02-11T16:20:30.377" v="584" actId="14100"/>
          <ac:picMkLst>
            <pc:docMk/>
            <pc:sldMk cId="0" sldId="257"/>
            <ac:picMk id="1036" creationId="{4008161B-29F1-1163-4B7A-E2CABB07B6FB}"/>
          </ac:picMkLst>
        </pc:picChg>
        <pc:picChg chg="add mod">
          <ac:chgData name="Charlotte  Rutter" userId="160ff53a-fbf8-44e9-bd7d-8596248049be" providerId="ADAL" clId="{5CEC8519-1AD5-4052-AF8E-F7B682BFBF80}" dt="2025-02-11T16:58:17.511" v="1102" actId="1076"/>
          <ac:picMkLst>
            <pc:docMk/>
            <pc:sldMk cId="0" sldId="257"/>
            <ac:picMk id="1038" creationId="{D0A5C588-C48C-EEA2-D922-5B230722396C}"/>
          </ac:picMkLst>
        </pc:picChg>
        <pc:picChg chg="add mod">
          <ac:chgData name="Charlotte  Rutter" userId="160ff53a-fbf8-44e9-bd7d-8596248049be" providerId="ADAL" clId="{5CEC8519-1AD5-4052-AF8E-F7B682BFBF80}" dt="2025-02-11T16:58:29.055" v="1106" actId="1076"/>
          <ac:picMkLst>
            <pc:docMk/>
            <pc:sldMk cId="0" sldId="257"/>
            <ac:picMk id="1040" creationId="{90CCF419-7754-2EE9-0AE8-D8584FE0DF24}"/>
          </ac:picMkLst>
        </pc:picChg>
        <pc:picChg chg="add mod">
          <ac:chgData name="Charlotte  Rutter" userId="160ff53a-fbf8-44e9-bd7d-8596248049be" providerId="ADAL" clId="{5CEC8519-1AD5-4052-AF8E-F7B682BFBF80}" dt="2025-02-11T16:58:27.447" v="1105" actId="1076"/>
          <ac:picMkLst>
            <pc:docMk/>
            <pc:sldMk cId="0" sldId="257"/>
            <ac:picMk id="1042" creationId="{95021FE1-2857-F83A-67AC-47AF21B0FAE5}"/>
          </ac:picMkLst>
        </pc:picChg>
        <pc:picChg chg="add mod">
          <ac:chgData name="Charlotte  Rutter" userId="160ff53a-fbf8-44e9-bd7d-8596248049be" providerId="ADAL" clId="{5CEC8519-1AD5-4052-AF8E-F7B682BFBF80}" dt="2025-02-11T16:58:23.727" v="1104" actId="1076"/>
          <ac:picMkLst>
            <pc:docMk/>
            <pc:sldMk cId="0" sldId="257"/>
            <ac:picMk id="1044" creationId="{C4E25905-255F-4BCE-F9AD-E1DD190A82C7}"/>
          </ac:picMkLst>
        </pc:picChg>
        <pc:cxnChg chg="mod">
          <ac:chgData name="Charlotte  Rutter" userId="160ff53a-fbf8-44e9-bd7d-8596248049be" providerId="ADAL" clId="{5CEC8519-1AD5-4052-AF8E-F7B682BFBF80}" dt="2025-02-11T16:05:32.612" v="211" actId="1076"/>
          <ac:cxnSpMkLst>
            <pc:docMk/>
            <pc:sldMk cId="0" sldId="257"/>
            <ac:cxnSpMk id="7" creationId="{844FB12E-281E-D5F3-403E-18C97D30DD2C}"/>
          </ac:cxnSpMkLst>
        </pc:cxnChg>
        <pc:cxnChg chg="mod">
          <ac:chgData name="Charlotte  Rutter" userId="160ff53a-fbf8-44e9-bd7d-8596248049be" providerId="ADAL" clId="{5CEC8519-1AD5-4052-AF8E-F7B682BFBF80}" dt="2025-02-11T16:05:46.621" v="212" actId="1076"/>
          <ac:cxnSpMkLst>
            <pc:docMk/>
            <pc:sldMk cId="0" sldId="257"/>
            <ac:cxnSpMk id="10" creationId="{252280C0-D6D4-0BA0-C0EC-515483FB5B86}"/>
          </ac:cxnSpMkLst>
        </pc:cxnChg>
        <pc:cxnChg chg="mod">
          <ac:chgData name="Charlotte  Rutter" userId="160ff53a-fbf8-44e9-bd7d-8596248049be" providerId="ADAL" clId="{5CEC8519-1AD5-4052-AF8E-F7B682BFBF80}" dt="2025-02-11T16:05:51.620" v="213" actId="1076"/>
          <ac:cxnSpMkLst>
            <pc:docMk/>
            <pc:sldMk cId="0" sldId="257"/>
            <ac:cxnSpMk id="13" creationId="{7004E7A4-F763-C9E3-0E7D-E48F143C022A}"/>
          </ac:cxnSpMkLst>
        </pc:cxnChg>
        <pc:cxnChg chg="mod">
          <ac:chgData name="Charlotte  Rutter" userId="160ff53a-fbf8-44e9-bd7d-8596248049be" providerId="ADAL" clId="{5CEC8519-1AD5-4052-AF8E-F7B682BFBF80}" dt="2025-02-11T16:05:46.621" v="212" actId="1076"/>
          <ac:cxnSpMkLst>
            <pc:docMk/>
            <pc:sldMk cId="0" sldId="257"/>
            <ac:cxnSpMk id="16" creationId="{3C5CFEAD-4E1B-24B6-8FB7-47BBE71AD415}"/>
          </ac:cxnSpMkLst>
        </pc:cxnChg>
        <pc:cxnChg chg="del mod">
          <ac:chgData name="Charlotte  Rutter" userId="160ff53a-fbf8-44e9-bd7d-8596248049be" providerId="ADAL" clId="{5CEC8519-1AD5-4052-AF8E-F7B682BFBF80}" dt="2025-02-11T16:10:24.059" v="362" actId="478"/>
          <ac:cxnSpMkLst>
            <pc:docMk/>
            <pc:sldMk cId="0" sldId="257"/>
            <ac:cxnSpMk id="55" creationId="{9083761D-B832-F5B0-8515-2258B0EA3AC9}"/>
          </ac:cxnSpMkLst>
        </pc:cxnChg>
        <pc:cxnChg chg="del mod">
          <ac:chgData name="Charlotte  Rutter" userId="160ff53a-fbf8-44e9-bd7d-8596248049be" providerId="ADAL" clId="{5CEC8519-1AD5-4052-AF8E-F7B682BFBF80}" dt="2025-02-11T16:10:23.340" v="361" actId="478"/>
          <ac:cxnSpMkLst>
            <pc:docMk/>
            <pc:sldMk cId="0" sldId="257"/>
            <ac:cxnSpMk id="56" creationId="{EE1848C5-C538-CF6E-B92E-C72D66DED4CC}"/>
          </ac:cxnSpMkLst>
        </pc:cxnChg>
        <pc:cxnChg chg="del mod">
          <ac:chgData name="Charlotte  Rutter" userId="160ff53a-fbf8-44e9-bd7d-8596248049be" providerId="ADAL" clId="{5CEC8519-1AD5-4052-AF8E-F7B682BFBF80}" dt="2025-02-11T16:10:20.496" v="356" actId="478"/>
          <ac:cxnSpMkLst>
            <pc:docMk/>
            <pc:sldMk cId="0" sldId="257"/>
            <ac:cxnSpMk id="59" creationId="{07412AEB-33D5-A993-A2F6-17099D2C421D}"/>
          </ac:cxnSpMkLst>
        </pc:cxnChg>
        <pc:cxnChg chg="del mod">
          <ac:chgData name="Charlotte  Rutter" userId="160ff53a-fbf8-44e9-bd7d-8596248049be" providerId="ADAL" clId="{5CEC8519-1AD5-4052-AF8E-F7B682BFBF80}" dt="2025-02-11T16:10:19.644" v="355" actId="478"/>
          <ac:cxnSpMkLst>
            <pc:docMk/>
            <pc:sldMk cId="0" sldId="257"/>
            <ac:cxnSpMk id="64" creationId="{71B901B3-DC03-E62D-DED2-BEE2FA85C0D2}"/>
          </ac:cxnSpMkLst>
        </pc:cxnChg>
        <pc:cxnChg chg="del mod">
          <ac:chgData name="Charlotte  Rutter" userId="160ff53a-fbf8-44e9-bd7d-8596248049be" providerId="ADAL" clId="{5CEC8519-1AD5-4052-AF8E-F7B682BFBF80}" dt="2025-02-11T16:10:22.173" v="359" actId="478"/>
          <ac:cxnSpMkLst>
            <pc:docMk/>
            <pc:sldMk cId="0" sldId="257"/>
            <ac:cxnSpMk id="134" creationId="{0D1E6746-6992-35BB-7E39-ECCA0E3C1B82}"/>
          </ac:cxnSpMkLst>
        </pc:cxnChg>
        <pc:cxnChg chg="del mod">
          <ac:chgData name="Charlotte  Rutter" userId="160ff53a-fbf8-44e9-bd7d-8596248049be" providerId="ADAL" clId="{5CEC8519-1AD5-4052-AF8E-F7B682BFBF80}" dt="2025-02-11T16:10:21.564" v="358" actId="478"/>
          <ac:cxnSpMkLst>
            <pc:docMk/>
            <pc:sldMk cId="0" sldId="257"/>
            <ac:cxnSpMk id="140" creationId="{E20C08CC-8203-7B8E-A01C-E65FD1A76393}"/>
          </ac:cxnSpMkLst>
        </pc:cxnChg>
        <pc:cxnChg chg="del mod">
          <ac:chgData name="Charlotte  Rutter" userId="160ff53a-fbf8-44e9-bd7d-8596248049be" providerId="ADAL" clId="{5CEC8519-1AD5-4052-AF8E-F7B682BFBF80}" dt="2025-02-11T16:10:22.716" v="360" actId="478"/>
          <ac:cxnSpMkLst>
            <pc:docMk/>
            <pc:sldMk cId="0" sldId="257"/>
            <ac:cxnSpMk id="144" creationId="{681491FD-5A92-5AC9-58DC-E3B62BBCD6B1}"/>
          </ac:cxnSpMkLst>
        </pc:cxnChg>
        <pc:cxnChg chg="del mod">
          <ac:chgData name="Charlotte  Rutter" userId="160ff53a-fbf8-44e9-bd7d-8596248049be" providerId="ADAL" clId="{5CEC8519-1AD5-4052-AF8E-F7B682BFBF80}" dt="2025-02-11T16:10:21.036" v="357" actId="478"/>
          <ac:cxnSpMkLst>
            <pc:docMk/>
            <pc:sldMk cId="0" sldId="257"/>
            <ac:cxnSpMk id="149" creationId="{F42DC47F-5CDD-391A-5A00-96C9EEE81BF3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Google Shape;101;p1">
            <a:extLst>
              <a:ext uri="{FF2B5EF4-FFF2-40B4-BE49-F238E27FC236}">
                <a16:creationId xmlns:a16="http://schemas.microsoft.com/office/drawing/2014/main" id="{5A74F847-B264-DDCC-1F23-E307AB29FF1D}"/>
              </a:ext>
            </a:extLst>
          </p:cNvPr>
          <p:cNvSpPr/>
          <p:nvPr/>
        </p:nvSpPr>
        <p:spPr>
          <a:xfrm>
            <a:off x="-9788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0" name="Rectangle: Rounded Corners 59">
            <a:extLst>
              <a:ext uri="{FF2B5EF4-FFF2-40B4-BE49-F238E27FC236}">
                <a16:creationId xmlns:a16="http://schemas.microsoft.com/office/drawing/2014/main" id="{E7A9505E-A7BF-6170-0B83-35AB5AEF4D81}"/>
              </a:ext>
            </a:extLst>
          </p:cNvPr>
          <p:cNvSpPr/>
          <p:nvPr/>
        </p:nvSpPr>
        <p:spPr>
          <a:xfrm>
            <a:off x="5885909" y="1668488"/>
            <a:ext cx="3134622" cy="3423793"/>
          </a:xfrm>
          <a:prstGeom prst="round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" name="Google Shape;98;p1"/>
          <p:cNvSpPr txBox="1"/>
          <p:nvPr/>
        </p:nvSpPr>
        <p:spPr>
          <a:xfrm>
            <a:off x="9900" y="1132715"/>
            <a:ext cx="9144000" cy="4500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25" b="0" i="0" u="none" strike="noStrike" cap="none" dirty="0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rPr>
              <a:t>Rutter CE, et al. </a:t>
            </a:r>
            <a:r>
              <a:rPr lang="en-US" sz="1425" b="0" i="1" u="none" strike="noStrike" cap="none" dirty="0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rPr>
              <a:t>Thorax </a:t>
            </a:r>
            <a:r>
              <a:rPr lang="en-US" sz="1425" b="0" i="0" u="none" strike="noStrike" cap="none" dirty="0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rPr>
              <a:t>2025. DOI: 10.1136/thorax-2024-222118</a:t>
            </a:r>
            <a:endParaRPr sz="1275" b="0" i="0" u="none" strike="noStrike" cap="none" dirty="0">
              <a:solidFill>
                <a:srgbClr val="1C4587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 dirty="0">
              <a:solidFill>
                <a:srgbClr val="1C4587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9" name="Google Shape;99;p1"/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0" name="Google Shape;100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1" name="Google Shape;101;p1"/>
          <p:cNvSpPr/>
          <p:nvPr/>
        </p:nvSpPr>
        <p:spPr>
          <a:xfrm>
            <a:off x="-9788" y="5600949"/>
            <a:ext cx="396090" cy="277244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3" name="Google Shape;103;p1"/>
          <p:cNvGrpSpPr/>
          <p:nvPr/>
        </p:nvGrpSpPr>
        <p:grpSpPr>
          <a:xfrm>
            <a:off x="11944" y="6042407"/>
            <a:ext cx="8997713" cy="629438"/>
            <a:chOff x="15925" y="6022775"/>
            <a:chExt cx="11996950" cy="839250"/>
          </a:xfrm>
        </p:grpSpPr>
        <p:pic>
          <p:nvPicPr>
            <p:cNvPr id="104" name="Google Shape;104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9692825" y="6134375"/>
              <a:ext cx="2320050" cy="727650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05" name="Google Shape;105;p1"/>
            <p:cNvGrpSpPr/>
            <p:nvPr/>
          </p:nvGrpSpPr>
          <p:grpSpPr>
            <a:xfrm>
              <a:off x="3652725" y="6134368"/>
              <a:ext cx="5347800" cy="642550"/>
              <a:chOff x="3855450" y="6082493"/>
              <a:chExt cx="5347800" cy="642550"/>
            </a:xfrm>
          </p:grpSpPr>
          <p:sp>
            <p:nvSpPr>
              <p:cNvPr id="106" name="Google Shape;106;p1"/>
              <p:cNvSpPr txBox="1"/>
              <p:nvPr/>
            </p:nvSpPr>
            <p:spPr>
              <a:xfrm>
                <a:off x="3855450" y="6134376"/>
                <a:ext cx="5347800" cy="53857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8550" tIns="68550" rIns="68550" bIns="6855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725" b="1" i="0" u="none" strike="noStrike" cap="none" dirty="0">
                    <a:solidFill>
                      <a:srgbClr val="00AFF0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thorax.bmj.com                       @ThoraxBMJ</a:t>
                </a:r>
                <a:endParaRPr sz="1725" b="1" i="0" u="none" strike="noStrike" cap="none" dirty="0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pic>
            <p:nvPicPr>
              <p:cNvPr id="107" name="Google Shape;107;p1"/>
              <p:cNvPicPr preferRelativeResize="0"/>
              <p:nvPr/>
            </p:nvPicPr>
            <p:blipFill rotWithShape="1">
              <a:blip r:embed="rId5">
                <a:alphaModFix/>
              </a:blip>
              <a:srcRect/>
              <a:stretch/>
            </p:blipFill>
            <p:spPr>
              <a:xfrm>
                <a:off x="6639488" y="6082493"/>
                <a:ext cx="642550" cy="642550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pic>
          <p:nvPicPr>
            <p:cNvPr id="108" name="Google Shape;108;p1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9" name="Google Shape;109;p1"/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0" name="Google Shape;110;p1"/>
          <p:cNvSpPr txBox="1"/>
          <p:nvPr/>
        </p:nvSpPr>
        <p:spPr>
          <a:xfrm>
            <a:off x="105318" y="338446"/>
            <a:ext cx="6061306" cy="623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575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Risk factors for atopic and non-atopic asthma in school-aged children from high-, and low-and-middle-income countries</a:t>
            </a:r>
            <a:endParaRPr sz="1575" b="1" i="0" u="none" strike="noStrike" cap="none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1" name="Google Shape;111;p1"/>
          <p:cNvSpPr txBox="1"/>
          <p:nvPr/>
        </p:nvSpPr>
        <p:spPr>
          <a:xfrm>
            <a:off x="123469" y="1673604"/>
            <a:ext cx="4068000" cy="1944000"/>
          </a:xfrm>
          <a:prstGeom prst="round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2" name="Google Shape;112;p1"/>
          <p:cNvSpPr txBox="1"/>
          <p:nvPr/>
        </p:nvSpPr>
        <p:spPr>
          <a:xfrm>
            <a:off x="123468" y="3757883"/>
            <a:ext cx="4068000" cy="2016000"/>
          </a:xfrm>
          <a:prstGeom prst="round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US"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US"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023464F7-8D7C-E429-5495-D8812C6A72F6}"/>
              </a:ext>
            </a:extLst>
          </p:cNvPr>
          <p:cNvSpPr/>
          <p:nvPr/>
        </p:nvSpPr>
        <p:spPr>
          <a:xfrm>
            <a:off x="180008" y="2221441"/>
            <a:ext cx="1104900" cy="609600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Healthy controls</a:t>
            </a:r>
            <a:endParaRPr lang="en-GB" sz="1200" dirty="0"/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5A22B126-E4A0-C34F-F7AE-03BB57DCA051}"/>
              </a:ext>
            </a:extLst>
          </p:cNvPr>
          <p:cNvSpPr/>
          <p:nvPr/>
        </p:nvSpPr>
        <p:spPr>
          <a:xfrm>
            <a:off x="3005768" y="2189688"/>
            <a:ext cx="1104900" cy="609600"/>
          </a:xfrm>
          <a:prstGeom prst="ellipse">
            <a:avLst/>
          </a:prstGeom>
          <a:solidFill>
            <a:srgbClr val="CD51BE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Atopic asthma</a:t>
            </a:r>
            <a:endParaRPr lang="en-GB" sz="1200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79BDF7C3-2189-D9F6-4993-5CC83D23270E}"/>
              </a:ext>
            </a:extLst>
          </p:cNvPr>
          <p:cNvSpPr/>
          <p:nvPr/>
        </p:nvSpPr>
        <p:spPr>
          <a:xfrm>
            <a:off x="3001340" y="2901316"/>
            <a:ext cx="1104900" cy="609600"/>
          </a:xfrm>
          <a:prstGeom prst="ellipse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Non-atopic asthma</a:t>
            </a:r>
            <a:endParaRPr lang="en-GB" sz="1200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B6D58143-7E80-6CA1-3233-A2BBAD83599E}"/>
              </a:ext>
            </a:extLst>
          </p:cNvPr>
          <p:cNvSpPr/>
          <p:nvPr/>
        </p:nvSpPr>
        <p:spPr>
          <a:xfrm>
            <a:off x="1589481" y="1752662"/>
            <a:ext cx="1104900" cy="609600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Atopy only</a:t>
            </a:r>
            <a:endParaRPr lang="en-GB" sz="1200" dirty="0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844FB12E-281E-D5F3-403E-18C97D30DD2C}"/>
              </a:ext>
            </a:extLst>
          </p:cNvPr>
          <p:cNvCxnSpPr>
            <a:cxnSpLocks/>
            <a:stCxn id="2" idx="7"/>
            <a:endCxn id="5" idx="2"/>
          </p:cNvCxnSpPr>
          <p:nvPr/>
        </p:nvCxnSpPr>
        <p:spPr>
          <a:xfrm flipV="1">
            <a:off x="1123099" y="2057462"/>
            <a:ext cx="466382" cy="2532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252280C0-D6D4-0BA0-C0EC-515483FB5B86}"/>
              </a:ext>
            </a:extLst>
          </p:cNvPr>
          <p:cNvCxnSpPr>
            <a:cxnSpLocks/>
            <a:stCxn id="5" idx="6"/>
            <a:endCxn id="3" idx="1"/>
          </p:cNvCxnSpPr>
          <p:nvPr/>
        </p:nvCxnSpPr>
        <p:spPr>
          <a:xfrm>
            <a:off x="2694381" y="2057462"/>
            <a:ext cx="473196" cy="2215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7004E7A4-F763-C9E3-0E7D-E48F143C022A}"/>
              </a:ext>
            </a:extLst>
          </p:cNvPr>
          <p:cNvCxnSpPr>
            <a:cxnSpLocks/>
            <a:stCxn id="2" idx="5"/>
            <a:endCxn id="4" idx="2"/>
          </p:cNvCxnSpPr>
          <p:nvPr/>
        </p:nvCxnSpPr>
        <p:spPr>
          <a:xfrm>
            <a:off x="1123099" y="2741767"/>
            <a:ext cx="1878241" cy="4643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3C5CFEAD-4E1B-24B6-8FB7-47BBE71AD415}"/>
              </a:ext>
            </a:extLst>
          </p:cNvPr>
          <p:cNvCxnSpPr>
            <a:cxnSpLocks/>
            <a:stCxn id="2" idx="6"/>
            <a:endCxn id="3" idx="2"/>
          </p:cNvCxnSpPr>
          <p:nvPr/>
        </p:nvCxnSpPr>
        <p:spPr>
          <a:xfrm flipV="1">
            <a:off x="1284908" y="2494488"/>
            <a:ext cx="1720860" cy="317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40B18A10-B084-E30C-2972-7E65BE4FA923}"/>
              </a:ext>
            </a:extLst>
          </p:cNvPr>
          <p:cNvSpPr txBox="1"/>
          <p:nvPr/>
        </p:nvSpPr>
        <p:spPr>
          <a:xfrm>
            <a:off x="2013862" y="2984008"/>
            <a:ext cx="2561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  <a:endParaRPr lang="en-GB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5680BE-12A6-B15A-7468-41B34A7C60CE}"/>
              </a:ext>
            </a:extLst>
          </p:cNvPr>
          <p:cNvSpPr txBox="1"/>
          <p:nvPr/>
        </p:nvSpPr>
        <p:spPr>
          <a:xfrm>
            <a:off x="2831670" y="1902572"/>
            <a:ext cx="259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  <a:endParaRPr lang="en-GB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EAF57CA-6F7D-A94D-A440-89905AFADBEB}"/>
              </a:ext>
            </a:extLst>
          </p:cNvPr>
          <p:cNvSpPr txBox="1"/>
          <p:nvPr/>
        </p:nvSpPr>
        <p:spPr>
          <a:xfrm>
            <a:off x="1147868" y="1930406"/>
            <a:ext cx="261515" cy="311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  <a:endParaRPr lang="en-GB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E4ACE2D-0999-0617-18F1-055013AE1ED4}"/>
              </a:ext>
            </a:extLst>
          </p:cNvPr>
          <p:cNvSpPr txBox="1"/>
          <p:nvPr/>
        </p:nvSpPr>
        <p:spPr>
          <a:xfrm>
            <a:off x="2006835" y="2482466"/>
            <a:ext cx="272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  <a:endParaRPr lang="en-GB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AD2C3AB-1F38-CE05-C260-4AE5801C3129}"/>
              </a:ext>
            </a:extLst>
          </p:cNvPr>
          <p:cNvSpPr txBox="1"/>
          <p:nvPr/>
        </p:nvSpPr>
        <p:spPr>
          <a:xfrm>
            <a:off x="270848" y="3222929"/>
            <a:ext cx="2470964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 1: Pathways of asthma</a:t>
            </a:r>
          </a:p>
          <a:p>
            <a:r>
              <a:rPr lang="en-US" sz="800" dirty="0"/>
              <a:t>(adapted from Barreto et al, 2010) </a:t>
            </a:r>
            <a:endParaRPr lang="en-GB" sz="800" dirty="0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00000DB0-AFCF-702A-22DE-D97E63B286F9}"/>
              </a:ext>
            </a:extLst>
          </p:cNvPr>
          <p:cNvSpPr/>
          <p:nvPr/>
        </p:nvSpPr>
        <p:spPr>
          <a:xfrm>
            <a:off x="200252" y="4013496"/>
            <a:ext cx="916739" cy="547179"/>
          </a:xfrm>
          <a:prstGeom prst="rect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ISAAC</a:t>
            </a:r>
          </a:p>
          <a:p>
            <a:pPr algn="ctr"/>
            <a:r>
              <a:rPr lang="en-US" sz="1100" dirty="0"/>
              <a:t>9-12 years</a:t>
            </a:r>
          </a:p>
          <a:p>
            <a:pPr algn="ctr"/>
            <a:r>
              <a:rPr lang="en-US" sz="1100" dirty="0"/>
              <a:t>23,656</a:t>
            </a:r>
            <a:endParaRPr lang="en-GB" dirty="0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769E383B-F57C-D905-C773-2CF1DA8DCAE5}"/>
              </a:ext>
            </a:extLst>
          </p:cNvPr>
          <p:cNvSpPr/>
          <p:nvPr/>
        </p:nvSpPr>
        <p:spPr>
          <a:xfrm>
            <a:off x="1193775" y="4014502"/>
            <a:ext cx="916738" cy="544106"/>
          </a:xfrm>
          <a:prstGeom prst="rect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ALSPAC</a:t>
            </a:r>
          </a:p>
          <a:p>
            <a:pPr algn="ctr"/>
            <a:r>
              <a:rPr lang="en-US" sz="1100" dirty="0"/>
              <a:t>7-8 years</a:t>
            </a:r>
          </a:p>
          <a:p>
            <a:pPr algn="ctr"/>
            <a:r>
              <a:rPr lang="en-US" sz="1100" dirty="0"/>
              <a:t>2840</a:t>
            </a:r>
            <a:endParaRPr lang="en-GB" sz="1200" dirty="0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27355349-79C3-F5CD-B6D8-87D690D96889}"/>
              </a:ext>
            </a:extLst>
          </p:cNvPr>
          <p:cNvSpPr/>
          <p:nvPr/>
        </p:nvSpPr>
        <p:spPr>
          <a:xfrm>
            <a:off x="2187297" y="4026421"/>
            <a:ext cx="916738" cy="544106"/>
          </a:xfrm>
          <a:prstGeom prst="rect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SCAALA</a:t>
            </a:r>
          </a:p>
          <a:p>
            <a:pPr algn="ctr"/>
            <a:r>
              <a:rPr lang="en-US" sz="1100" dirty="0"/>
              <a:t>6-15 years</a:t>
            </a:r>
          </a:p>
          <a:p>
            <a:pPr algn="ctr"/>
            <a:r>
              <a:rPr lang="en-US" sz="1100" dirty="0"/>
              <a:t>5322</a:t>
            </a:r>
            <a:endParaRPr lang="en-GB" sz="1200" dirty="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B53D39B-7720-B739-A75D-18101E4C81E2}"/>
              </a:ext>
            </a:extLst>
          </p:cNvPr>
          <p:cNvSpPr/>
          <p:nvPr/>
        </p:nvSpPr>
        <p:spPr>
          <a:xfrm>
            <a:off x="3189502" y="4030246"/>
            <a:ext cx="916738" cy="543975"/>
          </a:xfrm>
          <a:prstGeom prst="rect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WASP</a:t>
            </a:r>
          </a:p>
          <a:p>
            <a:pPr algn="ctr"/>
            <a:r>
              <a:rPr lang="en-US" sz="1100" dirty="0"/>
              <a:t>9-17 years</a:t>
            </a:r>
          </a:p>
          <a:p>
            <a:pPr algn="ctr"/>
            <a:r>
              <a:rPr lang="en-US" sz="1100" dirty="0"/>
              <a:t>923</a:t>
            </a:r>
            <a:endParaRPr lang="en-GB" sz="1100" dirty="0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2B5AEF3B-CF6D-F5F7-397E-52EE4D63242B}"/>
              </a:ext>
            </a:extLst>
          </p:cNvPr>
          <p:cNvSpPr/>
          <p:nvPr/>
        </p:nvSpPr>
        <p:spPr>
          <a:xfrm>
            <a:off x="203978" y="4974130"/>
            <a:ext cx="917349" cy="522955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Healthy controls</a:t>
            </a:r>
          </a:p>
          <a:p>
            <a:pPr algn="ctr"/>
            <a:r>
              <a:rPr lang="en-US" sz="1100" dirty="0"/>
              <a:t>21,920</a:t>
            </a:r>
            <a:endParaRPr lang="en-GB" sz="1200" dirty="0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0FC4B71F-4F0E-32B6-05F1-440FC49FD592}"/>
              </a:ext>
            </a:extLst>
          </p:cNvPr>
          <p:cNvSpPr/>
          <p:nvPr/>
        </p:nvSpPr>
        <p:spPr>
          <a:xfrm>
            <a:off x="1202731" y="4977194"/>
            <a:ext cx="917348" cy="515048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Atopy</a:t>
            </a:r>
          </a:p>
          <a:p>
            <a:pPr algn="ctr"/>
            <a:r>
              <a:rPr lang="en-US" sz="1100" dirty="0"/>
              <a:t>only</a:t>
            </a:r>
          </a:p>
          <a:p>
            <a:pPr algn="ctr"/>
            <a:r>
              <a:rPr lang="en-US" sz="1100" dirty="0"/>
              <a:t>4870</a:t>
            </a:r>
            <a:endParaRPr lang="en-GB" sz="1200" dirty="0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034234FF-50D6-ACB5-B980-20392A9D6808}"/>
              </a:ext>
            </a:extLst>
          </p:cNvPr>
          <p:cNvSpPr/>
          <p:nvPr/>
        </p:nvSpPr>
        <p:spPr>
          <a:xfrm>
            <a:off x="2200410" y="4977194"/>
            <a:ext cx="916738" cy="515048"/>
          </a:xfrm>
          <a:prstGeom prst="rect">
            <a:avLst/>
          </a:prstGeom>
          <a:solidFill>
            <a:srgbClr val="CD51BE"/>
          </a:solidFill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Atopic asthma</a:t>
            </a:r>
          </a:p>
          <a:p>
            <a:pPr algn="ctr"/>
            <a:r>
              <a:rPr lang="en-US" sz="1100" dirty="0"/>
              <a:t>2642</a:t>
            </a:r>
            <a:endParaRPr lang="en-GB" sz="1100" dirty="0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3CD3797A-A615-58AA-C488-9FE71DAF53E4}"/>
              </a:ext>
            </a:extLst>
          </p:cNvPr>
          <p:cNvSpPr/>
          <p:nvPr/>
        </p:nvSpPr>
        <p:spPr>
          <a:xfrm>
            <a:off x="3189502" y="4981049"/>
            <a:ext cx="916738" cy="515048"/>
          </a:xfrm>
          <a:prstGeom prst="rect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Non-atopic asthma</a:t>
            </a:r>
          </a:p>
          <a:p>
            <a:pPr algn="ctr"/>
            <a:r>
              <a:rPr lang="en-US" sz="1100" dirty="0"/>
              <a:t>3309</a:t>
            </a:r>
            <a:endParaRPr lang="en-GB" sz="1200" dirty="0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36EFAACE-B552-C222-2056-F00AE0187F26}"/>
              </a:ext>
            </a:extLst>
          </p:cNvPr>
          <p:cNvSpPr txBox="1"/>
          <p:nvPr/>
        </p:nvSpPr>
        <p:spPr>
          <a:xfrm>
            <a:off x="5950022" y="4467986"/>
            <a:ext cx="3001088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Fig 3: Estimated odds ratios of risk factors for atopic asthma compared to non-atopic asthma, excluding atopy risk</a:t>
            </a:r>
            <a:endParaRPr lang="en-GB" sz="900" b="1" dirty="0">
              <a:latin typeface="+mn-lt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6F65C90A-2058-D343-40E4-B6471100B6C0}"/>
              </a:ext>
            </a:extLst>
          </p:cNvPr>
          <p:cNvSpPr txBox="1"/>
          <p:nvPr/>
        </p:nvSpPr>
        <p:spPr>
          <a:xfrm>
            <a:off x="260691" y="3754658"/>
            <a:ext cx="21419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Study name, ages, sample size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188F3B61-BB25-D9D9-758D-3994AD7E8467}"/>
              </a:ext>
            </a:extLst>
          </p:cNvPr>
          <p:cNvSpPr txBox="1"/>
          <p:nvPr/>
        </p:nvSpPr>
        <p:spPr>
          <a:xfrm>
            <a:off x="118787" y="4719115"/>
            <a:ext cx="4142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Outcomes (based on symptoms, medication and skin prick test)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80B8778B-6145-F0E2-8ACD-CC55494A89AD}"/>
              </a:ext>
            </a:extLst>
          </p:cNvPr>
          <p:cNvSpPr txBox="1"/>
          <p:nvPr/>
        </p:nvSpPr>
        <p:spPr>
          <a:xfrm>
            <a:off x="4300310" y="5187785"/>
            <a:ext cx="4706343" cy="576000"/>
          </a:xfrm>
          <a:prstGeom prst="roundRect">
            <a:avLst/>
          </a:prstGeom>
          <a:solidFill>
            <a:srgbClr val="00B0F0"/>
          </a:solidFill>
          <a:ln>
            <a:solidFill>
              <a:srgbClr val="0070C0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r>
              <a:rPr lang="en-US" sz="1250" dirty="0">
                <a:solidFill>
                  <a:schemeClr val="bg1"/>
                </a:solidFill>
              </a:rPr>
              <a:t>Conclusion: Risk factors for atopic and non-atopic asthma are very similar, once the risk factors for atopy itself are removed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15DFBD21-6DA1-58D9-D1B9-7AA68EB2C8EB}"/>
              </a:ext>
            </a:extLst>
          </p:cNvPr>
          <p:cNvSpPr txBox="1"/>
          <p:nvPr/>
        </p:nvSpPr>
        <p:spPr>
          <a:xfrm>
            <a:off x="270848" y="5506606"/>
            <a:ext cx="20665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Fig 2: Study data (N=32,741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4D122D0-B6D0-A85C-45B3-42CBE7C6AD2E}"/>
              </a:ext>
            </a:extLst>
          </p:cNvPr>
          <p:cNvSpPr txBox="1"/>
          <p:nvPr/>
        </p:nvSpPr>
        <p:spPr>
          <a:xfrm>
            <a:off x="4282689" y="1953208"/>
            <a:ext cx="1512000" cy="828000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Mixed effects logistic regression models for each pathway</a:t>
            </a:r>
            <a:endParaRPr lang="en-GB" sz="11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4AC45AC-A5F5-D4B8-B680-31964A46C6AA}"/>
              </a:ext>
            </a:extLst>
          </p:cNvPr>
          <p:cNvSpPr txBox="1"/>
          <p:nvPr/>
        </p:nvSpPr>
        <p:spPr>
          <a:xfrm>
            <a:off x="4283374" y="3755176"/>
            <a:ext cx="1512000" cy="1332000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Separate models for each risk factor</a:t>
            </a:r>
          </a:p>
          <a:p>
            <a:endParaRPr lang="en-US" sz="1100" dirty="0"/>
          </a:p>
          <a:p>
            <a:endParaRPr lang="en-US" sz="1100" dirty="0"/>
          </a:p>
          <a:p>
            <a:endParaRPr lang="en-US" sz="1100" dirty="0"/>
          </a:p>
          <a:p>
            <a:endParaRPr lang="en-US" sz="1100" dirty="0"/>
          </a:p>
          <a:p>
            <a:endParaRPr lang="en-US" sz="11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01C925F-0159-1BD7-9A21-7F5FFA4DFA83}"/>
              </a:ext>
            </a:extLst>
          </p:cNvPr>
          <p:cNvSpPr txBox="1"/>
          <p:nvPr/>
        </p:nvSpPr>
        <p:spPr>
          <a:xfrm>
            <a:off x="4283374" y="2771827"/>
            <a:ext cx="1512000" cy="972000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Adjusted for</a:t>
            </a:r>
          </a:p>
          <a:p>
            <a:pPr algn="ctr"/>
            <a:r>
              <a:rPr lang="en-US" sz="1100" dirty="0"/>
              <a:t>study, age, sex, country income and random intercept for centre</a:t>
            </a:r>
            <a:endParaRPr lang="en-GB" sz="1100" dirty="0"/>
          </a:p>
        </p:txBody>
      </p:sp>
      <p:pic>
        <p:nvPicPr>
          <p:cNvPr id="1026" name="Picture 2" descr="Paw icon">
            <a:extLst>
              <a:ext uri="{FF2B5EF4-FFF2-40B4-BE49-F238E27FC236}">
                <a16:creationId xmlns:a16="http://schemas.microsoft.com/office/drawing/2014/main" id="{03C597C0-67C0-F70B-1D19-145181D5C8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42387" y="4257599"/>
            <a:ext cx="313901" cy="313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4" name="AutoShape 4" descr="Dog icon">
            <a:extLst>
              <a:ext uri="{FF2B5EF4-FFF2-40B4-BE49-F238E27FC236}">
                <a16:creationId xmlns:a16="http://schemas.microsoft.com/office/drawing/2014/main" id="{15B5C300-8B5A-3B99-BD87-0BAF5B166D00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419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1034" name="Picture 10" descr="Home icon">
            <a:extLst>
              <a:ext uri="{FF2B5EF4-FFF2-40B4-BE49-F238E27FC236}">
                <a16:creationId xmlns:a16="http://schemas.microsoft.com/office/drawing/2014/main" id="{BAC71EAA-5613-6A1E-1E6E-AC83ECEE7A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5301" y="4202261"/>
            <a:ext cx="389231" cy="389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Fire icon">
            <a:extLst>
              <a:ext uri="{FF2B5EF4-FFF2-40B4-BE49-F238E27FC236}">
                <a16:creationId xmlns:a16="http://schemas.microsoft.com/office/drawing/2014/main" id="{D0A5C588-C48C-EEA2-D922-5B230722396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01730" y="4262212"/>
            <a:ext cx="323643" cy="3236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Dish Spoon Knife icon">
            <a:extLst>
              <a:ext uri="{FF2B5EF4-FFF2-40B4-BE49-F238E27FC236}">
                <a16:creationId xmlns:a16="http://schemas.microsoft.com/office/drawing/2014/main" id="{90CCF419-7754-2EE9-0AE8-D8584FE0DF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1097" y="4628427"/>
            <a:ext cx="397395" cy="3973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Baby icon">
            <a:extLst>
              <a:ext uri="{FF2B5EF4-FFF2-40B4-BE49-F238E27FC236}">
                <a16:creationId xmlns:a16="http://schemas.microsoft.com/office/drawing/2014/main" id="{95021FE1-2857-F83A-67AC-47AF21B0FAE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6913" y="4658593"/>
            <a:ext cx="364978" cy="3649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Smoke icon">
            <a:extLst>
              <a:ext uri="{FF2B5EF4-FFF2-40B4-BE49-F238E27FC236}">
                <a16:creationId xmlns:a16="http://schemas.microsoft.com/office/drawing/2014/main" id="{C4E25905-255F-4BCE-F9AD-E1DD190A82C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9485" y="4644024"/>
            <a:ext cx="379704" cy="3797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F664DA28-921B-2E66-316C-C510F08DE6EB}"/>
              </a:ext>
            </a:extLst>
          </p:cNvPr>
          <p:cNvSpPr txBox="1"/>
          <p:nvPr/>
        </p:nvSpPr>
        <p:spPr>
          <a:xfrm>
            <a:off x="4279404" y="1679963"/>
            <a:ext cx="1512000" cy="289441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Methods</a:t>
            </a:r>
            <a:endParaRPr lang="en-US" sz="1100" dirty="0"/>
          </a:p>
        </p:txBody>
      </p:sp>
      <p:pic>
        <p:nvPicPr>
          <p:cNvPr id="67" name="Picture 66" descr="A graph with colorful dots and lines&#10;&#10;Description automatically generated">
            <a:extLst>
              <a:ext uri="{FF2B5EF4-FFF2-40B4-BE49-F238E27FC236}">
                <a16:creationId xmlns:a16="http://schemas.microsoft.com/office/drawing/2014/main" id="{7E418795-BD73-8FC7-AD35-EFA1AADCD47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071759" y="1869629"/>
            <a:ext cx="2757615" cy="2551144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</TotalTime>
  <Words>219</Words>
  <Application>Microsoft Office PowerPoint</Application>
  <PresentationFormat>On-screen Show (4:3)</PresentationFormat>
  <Paragraphs>5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orax author instructions for visual abstracts (VAs)</dc:title>
  <dc:creator>Colantonio</dc:creator>
  <cp:lastModifiedBy>Charlotte  Rutter</cp:lastModifiedBy>
  <cp:revision>4</cp:revision>
  <dcterms:created xsi:type="dcterms:W3CDTF">2018-02-16T17:34:16Z</dcterms:created>
  <dcterms:modified xsi:type="dcterms:W3CDTF">2025-02-11T16:59:51Z</dcterms:modified>
</cp:coreProperties>
</file>